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9EF484-2EF8-42E4-9DB3-A8FC08AFFA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FA8922F-52CE-43C6-9AFA-B3C205C69D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26F39D-CFAF-4C25-8793-02B4DE4025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1B977-AB74-4775-9807-B3246965A583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A8E50A-B21F-4082-B913-97CC0B8236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395FCB-1DF6-49D9-8EA1-B3FFC544CC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F4F3-ECC5-4CBB-B0A3-A74647DB2A2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050751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FDD5BF-EB90-41E2-9B0B-9A3EA62A5C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152684-CC5C-4B86-98F7-B875FFADF7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19F3B7-F48A-4B5E-9F97-369C5C4900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1B977-AB74-4775-9807-B3246965A583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BDCA02-B059-4506-BD06-E85F1187E8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EA25C7-FFE5-4EB7-8CFA-FEB6C0721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F4F3-ECC5-4CBB-B0A3-A74647DB2A2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993751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F6C88AB-4694-49BA-9401-31A43C56DBF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9240B3-9090-4876-ABF2-9A162C12EF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E023E0-AEE8-4BD0-878E-4FD636DD6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1B977-AB74-4775-9807-B3246965A583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0EA44D-CE72-4BF0-9A34-225486247D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8F14C2-7E83-4E73-9AB5-F9AC9C8C5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F4F3-ECC5-4CBB-B0A3-A74647DB2A2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665207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AA29D7-90B6-4091-90D7-C184C74F0A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C0D469-53C8-4B47-B676-57A7C3A7EE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686D51-1EDD-4B3F-9FFA-05CF06E1C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1B977-AB74-4775-9807-B3246965A583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ECBF57-4E79-445C-804E-97031C2C11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A7CFE2-02DD-4A63-9EE5-E58355EC3A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F4F3-ECC5-4CBB-B0A3-A74647DB2A2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39751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826351-BD3C-4B4D-BD96-A8807427C4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EDFFE0-97B0-43B9-986E-E16DC792C9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4C3F06-1249-4390-B97C-7F07663633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1B977-AB74-4775-9807-B3246965A583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B159E8-8D74-4A2D-AF7F-1E5A4A755C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E371D0-A1D7-4F65-AF2D-1FA09BC659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F4F3-ECC5-4CBB-B0A3-A74647DB2A2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2391115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A13AE-9AAF-4EC8-8385-1BC319F650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05AA88-8365-4CD1-AD11-55E4C8DD659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B22628-71EA-49FD-B880-DA465FDB3F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EE686F-2FF0-43C5-84F8-470E8E9743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1B977-AB74-4775-9807-B3246965A583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8FC51D-BD9B-4CCB-B159-710E0A4AED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A2D629-4886-4CE1-9B31-1F7202DA6C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F4F3-ECC5-4CBB-B0A3-A74647DB2A2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6452070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53E9BF-C697-43CF-A8D0-24BAF1E7F2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07DB7C-1139-4F5F-B1C0-9593D3A55F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E29830-396F-401B-ACBC-AFBE6387D0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F173555-9280-4E70-ACED-432798F9B2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B5DD9A-1999-45B3-9311-900569BED7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2ECEAAB-6A99-4525-91C7-5B91D79C58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1B977-AB74-4775-9807-B3246965A583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2CA0EE0-A788-4B73-AD1C-E067DF1262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8BF249E-D760-4264-99F8-8AD0426284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F4F3-ECC5-4CBB-B0A3-A74647DB2A2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933383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EBC4C2-2E7F-4CFD-A9CB-999F104998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F50D2FC-F40D-49DA-8C4B-9A525CA0F4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1B977-AB74-4775-9807-B3246965A583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A82C6F5-3EB4-46C7-8C3A-62D95F3F5C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7749806-ADC5-4992-ABC4-BFFE02D35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F4F3-ECC5-4CBB-B0A3-A74647DB2A2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1068883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E183508-06C9-49B4-8300-93FFD1E9B6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1B977-AB74-4775-9807-B3246965A583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15D6B90-86B6-4C93-9771-146EB9BB53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F554418-C4A1-4FEA-A903-005C1A5A2D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F4F3-ECC5-4CBB-B0A3-A74647DB2A2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682682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1EA674-0C90-45A5-A3B1-B67EC97607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98F6A6-86BC-4317-8EED-ED65CEE35A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D5207B4-92C5-4DBC-B5C5-F7DDA7B147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F5C1962-3F19-472B-9923-F28EE6A9E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1B977-AB74-4775-9807-B3246965A583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949237-1F2F-4C33-BCE3-E58F7B9B22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B229A3-39C0-4392-AB1C-80FDD46B46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F4F3-ECC5-4CBB-B0A3-A74647DB2A2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29722737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627CB2-5707-4562-A965-86A2908B48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5B548AA-2C75-4ADC-93E5-EC19F8FB6F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D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60A757-AFF1-4044-9CB5-8B59B61385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8B8DEA-55C1-41AA-9920-2DADBF1273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1B977-AB74-4775-9807-B3246965A583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6F350E-D88C-48C6-BB01-29B243C8A9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EF19E3-AC9C-4674-903F-16E155C394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F4F3-ECC5-4CBB-B0A3-A74647DB2A2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423011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55DAE3D-F30A-465C-AA2F-CE890E6EA7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1A37EB-6288-4A26-B345-EA256737E4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E1D925-80BA-448F-B3C5-9DC313D1E3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51B977-AB74-4775-9807-B3246965A583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B89B5B-411D-4204-9491-1903005999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F36686-EDC0-4E5E-A4A5-64058F190E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AFF4F3-ECC5-4CBB-B0A3-A74647DB2A2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676666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74112BD-D24F-42AB-9E64-06AB2F6AC9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96580" y="637563"/>
            <a:ext cx="8942664" cy="557029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B7684CB-FED7-6BDA-567B-9431C265E2CA}"/>
              </a:ext>
            </a:extLst>
          </p:cNvPr>
          <p:cNvSpPr txBox="1"/>
          <p:nvPr/>
        </p:nvSpPr>
        <p:spPr>
          <a:xfrm>
            <a:off x="3884103" y="1736521"/>
            <a:ext cx="70551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D" dirty="0"/>
              <a:t>Table 1a. Reference range of WBC, RBC, HGB, HCT, MCV, MCH, MCHC </a:t>
            </a:r>
            <a:r>
              <a:rPr lang="en-US" dirty="0"/>
              <a:t>for healthy babies aged 1-4 months</a:t>
            </a:r>
            <a:endParaRPr lang="en-ID" dirty="0"/>
          </a:p>
        </p:txBody>
      </p:sp>
    </p:spTree>
    <p:extLst>
      <p:ext uri="{BB962C8B-B14F-4D97-AF65-F5344CB8AC3E}">
        <p14:creationId xmlns:p14="http://schemas.microsoft.com/office/powerpoint/2010/main" val="37017683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E448DB9-4005-42D4-B4E3-84D297FCE5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2994" y="679508"/>
            <a:ext cx="9110755" cy="536056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0F15C94-9E57-37FF-5060-AF07FC5184E6}"/>
              </a:ext>
            </a:extLst>
          </p:cNvPr>
          <p:cNvSpPr txBox="1"/>
          <p:nvPr/>
        </p:nvSpPr>
        <p:spPr>
          <a:xfrm>
            <a:off x="3088363" y="1686187"/>
            <a:ext cx="57800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ble 1b. Reference range of RDW SD, RDW CV, PDW, MPV, PCT, neutrophil for healthy babies aged 1-4 months</a:t>
            </a:r>
          </a:p>
        </p:txBody>
      </p:sp>
    </p:spTree>
    <p:extLst>
      <p:ext uri="{BB962C8B-B14F-4D97-AF65-F5344CB8AC3E}">
        <p14:creationId xmlns:p14="http://schemas.microsoft.com/office/powerpoint/2010/main" val="26723428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3F3D563-5F18-45CF-AAF2-865D6081BC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8696" y="813731"/>
            <a:ext cx="9664350" cy="519278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51FCF1A-B58B-7FF2-EE47-7596075EA1AA}"/>
              </a:ext>
            </a:extLst>
          </p:cNvPr>
          <p:cNvSpPr txBox="1"/>
          <p:nvPr/>
        </p:nvSpPr>
        <p:spPr>
          <a:xfrm>
            <a:off x="2818700" y="2072081"/>
            <a:ext cx="758364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ble 1c. Reference range of lymphocyte, monocyte, eosinophil, eosinophil </a:t>
            </a:r>
            <a:r>
              <a:rPr lang="en-US" dirty="0" err="1"/>
              <a:t>absolut</a:t>
            </a:r>
            <a:r>
              <a:rPr lang="en-US" dirty="0"/>
              <a:t>, basophil, basophil </a:t>
            </a:r>
            <a:r>
              <a:rPr lang="en-US" dirty="0" err="1"/>
              <a:t>absolut</a:t>
            </a:r>
            <a:r>
              <a:rPr lang="en-US" dirty="0"/>
              <a:t>, IPF, IG for healthy babies aged 1-4 months</a:t>
            </a:r>
          </a:p>
        </p:txBody>
      </p:sp>
    </p:spTree>
    <p:extLst>
      <p:ext uri="{BB962C8B-B14F-4D97-AF65-F5344CB8AC3E}">
        <p14:creationId xmlns:p14="http://schemas.microsoft.com/office/powerpoint/2010/main" val="16835508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B24FB39-580B-41CD-9CE9-CC663174EC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8250" y="363113"/>
            <a:ext cx="7356323" cy="586151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0EEE926-675E-8C06-6A28-996C5ADC6DBA}"/>
              </a:ext>
            </a:extLst>
          </p:cNvPr>
          <p:cNvSpPr txBox="1"/>
          <p:nvPr/>
        </p:nvSpPr>
        <p:spPr>
          <a:xfrm>
            <a:off x="3884103" y="1375795"/>
            <a:ext cx="555351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ble 1d. Reference range of IRF, RPI, reticulocyte hemoglobin, reticulocyte hemoglobin %, reticulocyte hemoglobin in million for healthy babies aged 1-4 months</a:t>
            </a:r>
          </a:p>
        </p:txBody>
      </p:sp>
    </p:spTree>
    <p:extLst>
      <p:ext uri="{BB962C8B-B14F-4D97-AF65-F5344CB8AC3E}">
        <p14:creationId xmlns:p14="http://schemas.microsoft.com/office/powerpoint/2010/main" val="42117943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4</TotalTime>
  <Words>105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lindungan ringoringo</dc:creator>
  <cp:lastModifiedBy>parlindungan ringoringo</cp:lastModifiedBy>
  <cp:revision>2</cp:revision>
  <dcterms:created xsi:type="dcterms:W3CDTF">2022-02-16T21:41:30Z</dcterms:created>
  <dcterms:modified xsi:type="dcterms:W3CDTF">2022-07-23T21:39:10Z</dcterms:modified>
</cp:coreProperties>
</file>